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um" initials="w" lastIdx="2" clrIdx="0">
    <p:extLst>
      <p:ext uri="{19B8F6BF-5375-455C-9EA6-DF929625EA0E}">
        <p15:presenceInfo xmlns:p15="http://schemas.microsoft.com/office/powerpoint/2012/main" userId="wu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99" d="100"/>
          <a:sy n="99" d="100"/>
        </p:scale>
        <p:origin x="67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um\Desktop\S&#322;u&#380;bowe\WUM%20&amp;%20UofL\Projekty%20-%20Wyniki\P2X7\Toksyczno&#347;&#263;%20AMPCP%20i%20AR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um\Desktop\S&#322;u&#380;bowe\WUM%20&amp;%20UofL\Projekty%20-%20Wyniki\P2X7\Toksyczno&#347;&#263;%20AMPCP%20i%20AR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4823-4D55-BD7E-DB5AFB1663A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$3:$E$3</c:f>
                <c:numCache>
                  <c:formatCode>General</c:formatCode>
                  <c:ptCount val="5"/>
                  <c:pt idx="0">
                    <c:v>12.020815280171307</c:v>
                  </c:pt>
                  <c:pt idx="1">
                    <c:v>5.6568542494923806</c:v>
                  </c:pt>
                  <c:pt idx="2">
                    <c:v>14.849242404917497</c:v>
                  </c:pt>
                  <c:pt idx="3">
                    <c:v>19.798989873223331</c:v>
                  </c:pt>
                  <c:pt idx="4">
                    <c:v>0.70710678118654757</c:v>
                  </c:pt>
                </c:numCache>
              </c:numRef>
            </c:plus>
            <c:minus>
              <c:numRef>
                <c:f>Sheet1!$A$3:$E$3</c:f>
                <c:numCache>
                  <c:formatCode>General</c:formatCode>
                  <c:ptCount val="5"/>
                  <c:pt idx="0">
                    <c:v>12.020815280171307</c:v>
                  </c:pt>
                  <c:pt idx="1">
                    <c:v>5.6568542494923806</c:v>
                  </c:pt>
                  <c:pt idx="2">
                    <c:v>14.849242404917497</c:v>
                  </c:pt>
                  <c:pt idx="3">
                    <c:v>19.798989873223331</c:v>
                  </c:pt>
                  <c:pt idx="4">
                    <c:v>0.70710678118654757</c:v>
                  </c:pt>
                </c:numCache>
              </c:numRef>
            </c:minus>
            <c:spPr>
              <a:noFill/>
              <a:ln w="19050" cap="sq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1:$E$1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A$2:$E$2</c:f>
              <c:numCache>
                <c:formatCode>General</c:formatCode>
                <c:ptCount val="5"/>
                <c:pt idx="0">
                  <c:v>73.5</c:v>
                </c:pt>
                <c:pt idx="1">
                  <c:v>77</c:v>
                </c:pt>
                <c:pt idx="2">
                  <c:v>74.5</c:v>
                </c:pt>
                <c:pt idx="3">
                  <c:v>85</c:v>
                </c:pt>
                <c:pt idx="4">
                  <c:v>79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23-4D55-BD7E-DB5AFB166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hBFU</a:t>
                </a:r>
                <a:r>
                  <a:rPr lang="pl-PL" dirty="0"/>
                  <a:t>-E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C99C-404C-9A9B-12100A4E3D1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$27:$E$27</c:f>
                <c:numCache>
                  <c:formatCode>General</c:formatCode>
                  <c:ptCount val="5"/>
                  <c:pt idx="0">
                    <c:v>4.2426406871192848</c:v>
                  </c:pt>
                  <c:pt idx="1">
                    <c:v>5.6568542494923806</c:v>
                  </c:pt>
                  <c:pt idx="2">
                    <c:v>8.4852813742385695</c:v>
                  </c:pt>
                  <c:pt idx="3">
                    <c:v>2.8284271247461903</c:v>
                  </c:pt>
                  <c:pt idx="4">
                    <c:v>1.4142135623730951</c:v>
                  </c:pt>
                </c:numCache>
              </c:numRef>
            </c:plus>
            <c:minus>
              <c:numRef>
                <c:f>Sheet1!$A$27:$E$27</c:f>
                <c:numCache>
                  <c:formatCode>General</c:formatCode>
                  <c:ptCount val="5"/>
                  <c:pt idx="0">
                    <c:v>4.2426406871192848</c:v>
                  </c:pt>
                  <c:pt idx="1">
                    <c:v>5.6568542494923806</c:v>
                  </c:pt>
                  <c:pt idx="2">
                    <c:v>8.4852813742385695</c:v>
                  </c:pt>
                  <c:pt idx="3">
                    <c:v>2.8284271247461903</c:v>
                  </c:pt>
                  <c:pt idx="4">
                    <c:v>1.4142135623730951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A$25:$E$25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A$26:$E$26</c:f>
              <c:numCache>
                <c:formatCode>General</c:formatCode>
                <c:ptCount val="5"/>
                <c:pt idx="0">
                  <c:v>62</c:v>
                </c:pt>
                <c:pt idx="1">
                  <c:v>70</c:v>
                </c:pt>
                <c:pt idx="2">
                  <c:v>73</c:v>
                </c:pt>
                <c:pt idx="3">
                  <c:v>61</c:v>
                </c:pt>
                <c:pt idx="4">
                  <c:v>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99C-404C-9A9B-12100A4E3D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hCFU</a:t>
                </a:r>
                <a:r>
                  <a:rPr lang="pl-PL" dirty="0"/>
                  <a:t>-GM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843E-4356-B9B9-5A375E4BDCF9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$50:$E$50</c:f>
                <c:numCache>
                  <c:formatCode>General</c:formatCode>
                  <c:ptCount val="5"/>
                  <c:pt idx="0">
                    <c:v>9.8994949366116654</c:v>
                  </c:pt>
                  <c:pt idx="1">
                    <c:v>4.9497474683058327</c:v>
                  </c:pt>
                  <c:pt idx="2">
                    <c:v>8.4852813742385695</c:v>
                  </c:pt>
                  <c:pt idx="3">
                    <c:v>2.1213203435596424</c:v>
                  </c:pt>
                  <c:pt idx="4">
                    <c:v>2.8284271247461903</c:v>
                  </c:pt>
                </c:numCache>
              </c:numRef>
            </c:plus>
            <c:minus>
              <c:numRef>
                <c:f>Sheet1!$A$50:$E$50</c:f>
                <c:numCache>
                  <c:formatCode>General</c:formatCode>
                  <c:ptCount val="5"/>
                  <c:pt idx="0">
                    <c:v>9.8994949366116654</c:v>
                  </c:pt>
                  <c:pt idx="1">
                    <c:v>4.9497474683058327</c:v>
                  </c:pt>
                  <c:pt idx="2">
                    <c:v>8.4852813742385695</c:v>
                  </c:pt>
                  <c:pt idx="3">
                    <c:v>2.1213203435596424</c:v>
                  </c:pt>
                  <c:pt idx="4">
                    <c:v>2.8284271247461903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A$48:$E$48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A$49:$E$49</c:f>
              <c:numCache>
                <c:formatCode>General</c:formatCode>
                <c:ptCount val="5"/>
                <c:pt idx="0">
                  <c:v>57</c:v>
                </c:pt>
                <c:pt idx="1">
                  <c:v>58.5</c:v>
                </c:pt>
                <c:pt idx="2">
                  <c:v>55</c:v>
                </c:pt>
                <c:pt idx="3">
                  <c:v>62.5</c:v>
                </c:pt>
                <c:pt idx="4">
                  <c:v>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3E-4356-B9B9-5A375E4BDC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mBFU</a:t>
                </a:r>
                <a:r>
                  <a:rPr lang="pl-PL" dirty="0"/>
                  <a:t>-E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bg1">
                  <a:lumMod val="50000"/>
                </a:schemeClr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9050">
                <a:solidFill>
                  <a:schemeClr val="tx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  <a:scene3d>
                <a:camera prst="orthographicFront"/>
                <a:lightRig rig="threePt" dir="t"/>
              </a:scene3d>
              <a:sp3d>
                <a:bevelT/>
              </a:sp3d>
            </c:spPr>
            <c:extLst>
              <c:ext xmlns:c16="http://schemas.microsoft.com/office/drawing/2014/chart" uri="{C3380CC4-5D6E-409C-BE32-E72D297353CC}">
                <c16:uniqueId val="{00000001-EE7B-42E4-ADA5-0CAC52680D68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$69:$E$69</c:f>
                <c:numCache>
                  <c:formatCode>General</c:formatCode>
                  <c:ptCount val="5"/>
                  <c:pt idx="0">
                    <c:v>7.0710678118654755</c:v>
                  </c:pt>
                  <c:pt idx="1">
                    <c:v>0.70710678118654757</c:v>
                  </c:pt>
                  <c:pt idx="2">
                    <c:v>4.2426406871192848</c:v>
                  </c:pt>
                  <c:pt idx="3">
                    <c:v>12.727922061357855</c:v>
                  </c:pt>
                  <c:pt idx="4">
                    <c:v>5.6568542494923806</c:v>
                  </c:pt>
                </c:numCache>
              </c:numRef>
            </c:plus>
            <c:minus>
              <c:numRef>
                <c:f>Sheet1!$A$69:$E$69</c:f>
                <c:numCache>
                  <c:formatCode>General</c:formatCode>
                  <c:ptCount val="5"/>
                  <c:pt idx="0">
                    <c:v>7.0710678118654755</c:v>
                  </c:pt>
                  <c:pt idx="1">
                    <c:v>0.70710678118654757</c:v>
                  </c:pt>
                  <c:pt idx="2">
                    <c:v>4.2426406871192848</c:v>
                  </c:pt>
                  <c:pt idx="3">
                    <c:v>12.727922061357855</c:v>
                  </c:pt>
                  <c:pt idx="4">
                    <c:v>5.6568542494923806</c:v>
                  </c:pt>
                </c:numCache>
              </c:numRef>
            </c:minus>
            <c:spPr>
              <a:ln w="19050" cap="sq"/>
            </c:spPr>
          </c:errBars>
          <c:cat>
            <c:strRef>
              <c:f>Sheet1!$A$67:$E$67</c:f>
              <c:strCache>
                <c:ptCount val="5"/>
                <c:pt idx="0">
                  <c:v>Vehicle</c:v>
                </c:pt>
                <c:pt idx="1">
                  <c:v>10µM</c:v>
                </c:pt>
                <c:pt idx="2">
                  <c:v>30µM</c:v>
                </c:pt>
                <c:pt idx="3">
                  <c:v>50µM</c:v>
                </c:pt>
                <c:pt idx="4">
                  <c:v>100µM</c:v>
                </c:pt>
              </c:strCache>
            </c:strRef>
          </c:cat>
          <c:val>
            <c:numRef>
              <c:f>Sheet1!$A$68:$E$68</c:f>
              <c:numCache>
                <c:formatCode>General</c:formatCode>
                <c:ptCount val="5"/>
                <c:pt idx="0">
                  <c:v>123</c:v>
                </c:pt>
                <c:pt idx="1">
                  <c:v>121.5</c:v>
                </c:pt>
                <c:pt idx="2">
                  <c:v>129</c:v>
                </c:pt>
                <c:pt idx="3">
                  <c:v>123</c:v>
                </c:pt>
                <c:pt idx="4">
                  <c:v>1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E7B-42E4-ADA5-0CAC52680D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1390712"/>
        <c:axId val="551391040"/>
      </c:barChart>
      <c:catAx>
        <c:axId val="551390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1040"/>
        <c:crosses val="autoZero"/>
        <c:auto val="1"/>
        <c:lblAlgn val="ctr"/>
        <c:lblOffset val="100"/>
        <c:noMultiLvlLbl val="0"/>
      </c:catAx>
      <c:valAx>
        <c:axId val="55139104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pl-PL" dirty="0"/>
                  <a:t>No. of </a:t>
                </a:r>
                <a:r>
                  <a:rPr lang="pl-PL" dirty="0" err="1"/>
                  <a:t>mCFU</a:t>
                </a:r>
                <a:r>
                  <a:rPr lang="pl-PL" dirty="0"/>
                  <a:t>-GM </a:t>
                </a:r>
                <a:r>
                  <a:rPr lang="pl-PL" dirty="0" err="1"/>
                  <a:t>colonies</a:t>
                </a:r>
                <a:endParaRPr lang="pl-PL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13907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 b="1">
          <a:solidFill>
            <a:sysClr val="windowText" lastClr="000000"/>
          </a:solidFill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98DF392-3995-4E1C-9656-77EEA6400C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4E2F6FB1-855C-4775-979C-31F64D520F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1E3129CC-A7E9-4FBC-8F96-1E2436352F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586CFB72-5A20-496C-8265-CD4AF458D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AF446E2-39B2-4845-8773-DB4A37D71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7688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437740E-527B-48FE-B5F7-6FED07C25D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9F8B0B76-A9AC-408D-AA05-B2BAC88A7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72203568-1E2C-4820-B2D8-A355E3B67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DC939C5C-51AA-4F44-A649-DBDEF6392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B414A93-2D71-49C4-B67E-63108F677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93853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B0CE0CC2-0278-42B8-8E4F-942FDA1217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395881CF-0EFB-4D8F-9819-DA2B5ECB74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DFA768B3-C939-4B5C-8499-74D0A6A2D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B3D97E62-1D31-47B1-A6D1-9BC37D913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9521F2F0-36E1-499C-AFD1-C5B6D6D93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93379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A6B0A5CD-995D-4555-A0D8-B5B5C25409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34F5A3C4-3FCD-45C6-8186-FB8C233876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5CA11101-FB25-4D0C-86A6-A3B6599A3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AE27A5E1-A78C-4C07-8006-12B72BA5D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FA9D51E-6C6A-4ABE-BE4F-88AA54856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607641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BD832E1-6E8F-4C54-8837-5D1210C320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969E5849-6F8B-4085-8050-2F07201F2D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4154C863-B039-4A57-A710-578D169DFB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5C7C92CF-0628-40A6-B0FF-D1A34BAAD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E6B8178-1701-4F4B-A24D-C7766D21B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83948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F7FBC52E-40B8-4A75-85E7-1E8163309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93E637A7-0A04-4898-8996-1CA176592C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F9A9A912-725D-4CAE-90AE-DF6E7E4D1A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76B6AE77-1C00-43DE-B199-26F2B63D1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7D284272-E0FF-4EDC-B59A-AE07B1E21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51E7E1DC-3BC2-400C-B6BB-8A1DA3C4E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831744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5E4985A-21E0-401A-B3BB-4822E917B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8EE44C59-2B4D-4DAF-BE77-56AE3D006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68768E04-3976-495D-8EB5-B0BCFB9F1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56A26610-187C-40C9-855A-DAA7CBF58F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43F50FB2-FE70-492D-A17B-BB57F9E684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64B93A6A-345F-4040-9F11-8E0FDBE4A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BAAB5559-16BC-4A46-AECA-358C162DE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9D1DA4E9-13BE-4BB4-9F8A-1B83BE29C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51818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700B1418-014F-4E0F-9E19-C9F47E7136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BB029A3C-D260-44F0-AA68-D87D4A758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42A50736-2F1E-4C13-843E-2F47E2ECC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1D722DB5-AA21-4BF7-91F9-8E520BFB7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241512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65C2B259-9A54-4DA2-9509-FCEAB3FF7F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F774EECF-18E4-463B-A6E6-94CEF8E99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4C3BE2BB-EA9E-425E-B047-652CA2AD0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70598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D1A63E71-278F-456F-8AAC-428575ABC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5F001588-7193-491E-8900-45218201E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0456869C-63F6-4E7B-A438-A1518F7667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92C150A9-0D71-48D5-A657-BD73B589C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9C445F6E-6E7E-4845-80A9-B501A141D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1D4416BB-7695-4A8B-8397-1221EB7064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04842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724678D-BDB4-4EA1-9DAF-687E2548C1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1FF1504E-0A7C-4518-B084-C42FF1D781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A038BCC4-9224-485C-9A33-BB5F24C056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916FF6B1-979E-42BE-8064-F1A506798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201A9DAC-A8BD-41C4-8C1C-18E3C5515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B7682374-DD10-4BD0-83F5-BCD500F02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2651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AFAF328F-09E4-4343-86B1-E30532F248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38C30F71-B30F-40E2-9386-F9DFBD1566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FEBA0EC-FC42-4E6F-A866-0872AE8DF7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6D703-9E1B-4095-95D0-6ABE73AC14A5}" type="datetimeFigureOut">
              <a:rPr lang="pl-PL" smtClean="0"/>
              <a:t>03.08.2019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6CA4AE1-C50D-4DDD-9066-070497BEF4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3D709E13-D1F8-4E3D-9745-A79C3E949B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21D23-5D1D-42E0-BA75-ED08BDC1BACE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9702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a 4">
            <a:extLst>
              <a:ext uri="{FF2B5EF4-FFF2-40B4-BE49-F238E27FC236}">
                <a16:creationId xmlns:a16="http://schemas.microsoft.com/office/drawing/2014/main" id="{A46FF314-3387-434A-B6C5-08A4577AC5B7}"/>
              </a:ext>
            </a:extLst>
          </p:cNvPr>
          <p:cNvGrpSpPr/>
          <p:nvPr/>
        </p:nvGrpSpPr>
        <p:grpSpPr>
          <a:xfrm>
            <a:off x="786404" y="580887"/>
            <a:ext cx="10428247" cy="6105663"/>
            <a:chOff x="786404" y="580887"/>
            <a:chExt cx="10428247" cy="6105663"/>
          </a:xfrm>
        </p:grpSpPr>
        <p:graphicFrame>
          <p:nvGraphicFramePr>
            <p:cNvPr id="3" name="Chart 3">
              <a:extLst>
                <a:ext uri="{FF2B5EF4-FFF2-40B4-BE49-F238E27FC236}">
                  <a16:creationId xmlns:a16="http://schemas.microsoft.com/office/drawing/2014/main" id="{00000000-0008-0000-0000-000004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2020275"/>
                </p:ext>
              </p:extLst>
            </p:nvPr>
          </p:nvGraphicFramePr>
          <p:xfrm>
            <a:off x="786404" y="833369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4">
              <a:extLst>
                <a:ext uri="{FF2B5EF4-FFF2-40B4-BE49-F238E27FC236}">
                  <a16:creationId xmlns:a16="http://schemas.microsoft.com/office/drawing/2014/main" id="{00000000-0008-0000-0000-000005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33293098"/>
                </p:ext>
              </p:extLst>
            </p:nvPr>
          </p:nvGraphicFramePr>
          <p:xfrm>
            <a:off x="6174651" y="833369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Chart 6">
              <a:extLst>
                <a:ext uri="{FF2B5EF4-FFF2-40B4-BE49-F238E27FC236}">
                  <a16:creationId xmlns:a16="http://schemas.microsoft.com/office/drawing/2014/main" id="{00000000-0008-0000-0000-000007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90335059"/>
                </p:ext>
              </p:extLst>
            </p:nvPr>
          </p:nvGraphicFramePr>
          <p:xfrm>
            <a:off x="786404" y="3806550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Chart 1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86091997"/>
                </p:ext>
              </p:extLst>
            </p:nvPr>
          </p:nvGraphicFramePr>
          <p:xfrm>
            <a:off x="6174651" y="3806550"/>
            <a:ext cx="5040000" cy="28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" name="pole tekstowe 1">
              <a:extLst>
                <a:ext uri="{FF2B5EF4-FFF2-40B4-BE49-F238E27FC236}">
                  <a16:creationId xmlns:a16="http://schemas.microsoft.com/office/drawing/2014/main" id="{8A9A36AA-7776-46F4-9D23-C71E2E9DBABA}"/>
                </a:ext>
              </a:extLst>
            </p:cNvPr>
            <p:cNvSpPr txBox="1"/>
            <p:nvPr/>
          </p:nvSpPr>
          <p:spPr>
            <a:xfrm>
              <a:off x="816404" y="580887"/>
              <a:ext cx="103982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600" b="1" dirty="0"/>
                <a:t>ARL67156</a:t>
              </a:r>
            </a:p>
          </p:txBody>
        </p:sp>
        <p:sp>
          <p:nvSpPr>
            <p:cNvPr id="8" name="Prostokąt 7">
              <a:extLst>
                <a:ext uri="{FF2B5EF4-FFF2-40B4-BE49-F238E27FC236}">
                  <a16:creationId xmlns:a16="http://schemas.microsoft.com/office/drawing/2014/main" id="{1B9C9227-7195-4119-830E-ECD011BE6FF1}"/>
                </a:ext>
              </a:extLst>
            </p:cNvPr>
            <p:cNvSpPr/>
            <p:nvPr/>
          </p:nvSpPr>
          <p:spPr>
            <a:xfrm>
              <a:off x="816404" y="580887"/>
              <a:ext cx="10398247" cy="610566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l-PL"/>
            </a:p>
          </p:txBody>
        </p:sp>
      </p:grpSp>
      <p:sp>
        <p:nvSpPr>
          <p:cNvPr id="9" name="TextBox 1">
            <a:extLst>
              <a:ext uri="{FF2B5EF4-FFF2-40B4-BE49-F238E27FC236}">
                <a16:creationId xmlns:a16="http://schemas.microsoft.com/office/drawing/2014/main" id="{2D162B69-971B-49BA-B65A-D8B1E3A86A48}"/>
              </a:ext>
            </a:extLst>
          </p:cNvPr>
          <p:cNvSpPr txBox="1"/>
          <p:nvPr/>
        </p:nvSpPr>
        <p:spPr>
          <a:xfrm>
            <a:off x="9174025" y="46478"/>
            <a:ext cx="2521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b="1" dirty="0" err="1"/>
              <a:t>Supplementary</a:t>
            </a:r>
            <a:r>
              <a:rPr lang="en-US" b="1" dirty="0"/>
              <a:t> Figure </a:t>
            </a:r>
            <a:r>
              <a:rPr lang="pl-PL" b="1" dirty="0"/>
              <a:t>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7671959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94</TotalTime>
  <Words>2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wum</dc:creator>
  <cp:lastModifiedBy>Ratajczak,Mariusz</cp:lastModifiedBy>
  <cp:revision>75</cp:revision>
  <dcterms:created xsi:type="dcterms:W3CDTF">2019-07-02T07:51:08Z</dcterms:created>
  <dcterms:modified xsi:type="dcterms:W3CDTF">2019-08-04T02:29:50Z</dcterms:modified>
</cp:coreProperties>
</file>